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454791-CC40-4D38-9425-DFD965E0713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B27C19-87B3-45B8-A13E-C4F9A1B756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6150C-72F8-47A8-837C-DD1F88EDA5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D3CAE-C702-49C6-A1CC-FF4069AACD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E2F7C-48D4-48A7-B619-9E35256C12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287C4-F377-4B15-93A6-BA8953F547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F4C058-8FB8-4542-8101-DDE04D0304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A6FD1-C881-44F2-961E-1EE19565AB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A25545-D617-417E-8A25-21923400CC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59D4EF-9692-427F-A82C-1D9BBCDDB3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2731D2-2498-4993-9C33-9828F5A274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2CD34E-0052-4E52-893B-F08F0549CD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82CADC-679F-4B7C-9AEB-23BE61EDF54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xtensive and dynamic sporulation capacity within the human intestinal microbiot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971800" y="2063880"/>
            <a:ext cx="3200400" cy="276048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 P Browne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–4 (2016) doi:10.1038/nature17645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4-29T09:21:42Z</dcterms:created>
  <dc:creator>ravikumar.n</dc:creator>
  <dc:description/>
  <dc:language>en-US</dc:language>
  <cp:lastModifiedBy>R.Vijitha</cp:lastModifiedBy>
  <dcterms:modified xsi:type="dcterms:W3CDTF">2016-04-29T09:24:45Z</dcterms:modified>
  <cp:revision>2</cp:revision>
  <dc:subject/>
  <dc:title>Extensive and dynamic sporulation capacity within the human intestinal microbiota</dc:title>
</cp:coreProperties>
</file>